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_rels/presentation.xml.rels" ContentType="application/vnd.openxmlformats-package.relationships+xml"/>
  <Override PartName="/ppt/media/image3.tif" ContentType="image/tiff"/>
  <Override PartName="/ppt/media/image2.png" ContentType="image/png"/>
  <Override PartName="/ppt/media/image1.png" ContentType="image/png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ustom.xml" ContentType="application/vnd.openxmlformats-officedocument.custom-properties+xml"/>
  <Override PartName="/docProps/app.xml" ContentType="application/vnd.openxmlformats-officedocument.extended-properties+xml"/>
  <Override PartName="/docProps/core.xml" ContentType="application/vnd.openxmlformats-package.core-propertie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1.png"/><Relationship Id="rId3" Type="http://schemas.openxmlformats.org/officeDocument/2006/relationships/image" Target="../media/image2.png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pic>
        <p:nvPicPr>
          <p:cNvPr id="36" name="" descr="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37" name="" descr=""/>
          <p:cNvPicPr/>
          <p:nvPr/>
        </p:nvPicPr>
        <p:blipFill>
          <a:blip r:embed="rId3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I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I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/>
          <a:p>
            <a:pPr algn="ctr">
              <a:lnSpc>
                <a:spcPct val="100000"/>
              </a:lnSpc>
            </a:pPr>
            <a:r>
              <a:rPr b="0" lang="en-US" sz="44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Click to edit Master title style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0/03/17</a:t>
            </a:r>
            <a:endParaRPr b="0" lang="en-IN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p>
            <a:endParaRPr b="0" lang="en-IN" sz="2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AD8C3306-BD33-4EAE-AB9F-7B4D01D0681F}" type="slidenum">
              <a:rPr b="0" lang="en-IN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&lt;number&gt;</a:t>
            </a:fld>
            <a:endParaRPr b="0" lang="en-IN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ti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787680" y="5936400"/>
            <a:ext cx="7770240" cy="6994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Figure S8</a:t>
            </a:r>
            <a:r>
              <a:rPr b="0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  (A) Length of gene conversion tracts associated with crossovers and non-crossovers for wild type, 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mlh3Δ</a:t>
            </a:r>
            <a:r>
              <a:rPr b="0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, 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pch2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</a:rPr>
              <a:t></a:t>
            </a:r>
            <a:r>
              <a:rPr b="0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 and 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mlh3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</a:rPr>
              <a:t>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  pch2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</a:rPr>
              <a:t></a:t>
            </a:r>
            <a:r>
              <a:rPr b="0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.  Statistically significant difference (</a:t>
            </a:r>
            <a:r>
              <a:rPr b="0" i="1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P</a:t>
            </a:r>
            <a:r>
              <a:rPr b="0" lang="en-IN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 &lt; 0.001) between the two groups are marked by an asterisk (***).  (B) and (C) Line plot showing the breakdown of the number of gene conversion tracts associated with crossovers and non-crossovers in 500 bp intervals from 0 to 20 kb.  Dotted lines indicate the median length of the tracts. </a:t>
            </a:r>
            <a:endParaRPr b="0" lang="en-I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39" name="" descr=""/>
          <p:cNvPicPr/>
          <p:nvPr/>
        </p:nvPicPr>
        <p:blipFill>
          <a:blip r:embed="rId1"/>
          <a:stretch/>
        </p:blipFill>
        <p:spPr>
          <a:xfrm>
            <a:off x="837720" y="720000"/>
            <a:ext cx="7009920" cy="5063400"/>
          </a:xfrm>
          <a:prstGeom prst="rect">
            <a:avLst/>
          </a:prstGeom>
          <a:ln>
            <a:noFill/>
          </a:ln>
        </p:spPr>
      </p:pic>
    </p:spTree>
  </p:cSld>
  <p:timing>
    <p:tnLst>
      <p:par>
        <p:cTn id="1" dur="indefinite" restart="never" nodeType="tmRoot">
          <p:childTnLst>
            <p:seq>
              <p:cTn id="2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5.1.6.2$Linux_X86_64 LibreOffice_project/10m0$Build-2</Application>
  <Words>91</Words>
  <Paragraphs>1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07T07:31:18Z</dcterms:created>
  <dc:creator>Ajith V P</dc:creator>
  <dc:description/>
  <dc:language>en-IN</dc:language>
  <cp:lastModifiedBy/>
  <dcterms:modified xsi:type="dcterms:W3CDTF">2017-03-10T14:06:48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